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BBF6A6C-3082-43EC-BD2E-60040FDC56BB}" v="13" dt="2022-08-01T18:19:59.78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6" autoAdjust="0"/>
    <p:restoredTop sz="94660"/>
  </p:normalViewPr>
  <p:slideViewPr>
    <p:cSldViewPr snapToGrid="0">
      <p:cViewPr varScale="1">
        <p:scale>
          <a:sx n="86" d="100"/>
          <a:sy n="86" d="100"/>
        </p:scale>
        <p:origin x="4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bah Akhtar" userId="1c357625-e33f-447b-bc0a-de84de8ec01a" providerId="ADAL" clId="{8BBF6A6C-3082-43EC-BD2E-60040FDC56BB}"/>
    <pc:docChg chg="undo custSel modSld">
      <pc:chgData name="Sabah Akhtar" userId="1c357625-e33f-447b-bc0a-de84de8ec01a" providerId="ADAL" clId="{8BBF6A6C-3082-43EC-BD2E-60040FDC56BB}" dt="2022-08-01T18:21:17.461" v="425" actId="20577"/>
      <pc:docMkLst>
        <pc:docMk/>
      </pc:docMkLst>
      <pc:sldChg chg="addSp delSp modSp mod">
        <pc:chgData name="Sabah Akhtar" userId="1c357625-e33f-447b-bc0a-de84de8ec01a" providerId="ADAL" clId="{8BBF6A6C-3082-43EC-BD2E-60040FDC56BB}" dt="2022-08-01T18:21:17.461" v="425" actId="20577"/>
        <pc:sldMkLst>
          <pc:docMk/>
          <pc:sldMk cId="3297094394" sldId="257"/>
        </pc:sldMkLst>
        <pc:spChg chg="add mod">
          <ac:chgData name="Sabah Akhtar" userId="1c357625-e33f-447b-bc0a-de84de8ec01a" providerId="ADAL" clId="{8BBF6A6C-3082-43EC-BD2E-60040FDC56BB}" dt="2022-07-27T14:40:43.577" v="89" actId="1076"/>
          <ac:spMkLst>
            <pc:docMk/>
            <pc:sldMk cId="3297094394" sldId="257"/>
            <ac:spMk id="2" creationId="{B854B11C-CE5F-905A-1154-EE7ED62C4317}"/>
          </ac:spMkLst>
        </pc:spChg>
        <pc:spChg chg="add mod">
          <ac:chgData name="Sabah Akhtar" userId="1c357625-e33f-447b-bc0a-de84de8ec01a" providerId="ADAL" clId="{8BBF6A6C-3082-43EC-BD2E-60040FDC56BB}" dt="2022-07-27T14:40:43.577" v="89" actId="1076"/>
          <ac:spMkLst>
            <pc:docMk/>
            <pc:sldMk cId="3297094394" sldId="257"/>
            <ac:spMk id="4" creationId="{B8AB5389-FF08-0181-A8C5-B1788ED22682}"/>
          </ac:spMkLst>
        </pc:spChg>
        <pc:spChg chg="add mod">
          <ac:chgData name="Sabah Akhtar" userId="1c357625-e33f-447b-bc0a-de84de8ec01a" providerId="ADAL" clId="{8BBF6A6C-3082-43EC-BD2E-60040FDC56BB}" dt="2022-07-27T14:40:43.577" v="89" actId="1076"/>
          <ac:spMkLst>
            <pc:docMk/>
            <pc:sldMk cId="3297094394" sldId="257"/>
            <ac:spMk id="6" creationId="{045F4BAE-A7F9-2153-7047-9C8C6A6BFACA}"/>
          </ac:spMkLst>
        </pc:spChg>
        <pc:spChg chg="add mod">
          <ac:chgData name="Sabah Akhtar" userId="1c357625-e33f-447b-bc0a-de84de8ec01a" providerId="ADAL" clId="{8BBF6A6C-3082-43EC-BD2E-60040FDC56BB}" dt="2022-07-30T19:23:36.157" v="108" actId="14100"/>
          <ac:spMkLst>
            <pc:docMk/>
            <pc:sldMk cId="3297094394" sldId="257"/>
            <ac:spMk id="8" creationId="{D882B9C8-266A-31FC-2F48-451773857267}"/>
          </ac:spMkLst>
        </pc:spChg>
        <pc:spChg chg="add mod">
          <ac:chgData name="Sabah Akhtar" userId="1c357625-e33f-447b-bc0a-de84de8ec01a" providerId="ADAL" clId="{8BBF6A6C-3082-43EC-BD2E-60040FDC56BB}" dt="2022-08-01T18:20:17.128" v="160" actId="1076"/>
          <ac:spMkLst>
            <pc:docMk/>
            <pc:sldMk cId="3297094394" sldId="257"/>
            <ac:spMk id="10" creationId="{46F10B90-7102-0981-550D-C44EE518D0B6}"/>
          </ac:spMkLst>
        </pc:spChg>
        <pc:spChg chg="add mod">
          <ac:chgData name="Sabah Akhtar" userId="1c357625-e33f-447b-bc0a-de84de8ec01a" providerId="ADAL" clId="{8BBF6A6C-3082-43EC-BD2E-60040FDC56BB}" dt="2022-08-01T18:20:17.128" v="160" actId="1076"/>
          <ac:spMkLst>
            <pc:docMk/>
            <pc:sldMk cId="3297094394" sldId="257"/>
            <ac:spMk id="12" creationId="{F9EC8B84-287F-F410-7FDA-33F4D29AEED8}"/>
          </ac:spMkLst>
        </pc:spChg>
        <pc:spChg chg="add mod">
          <ac:chgData name="Sabah Akhtar" userId="1c357625-e33f-447b-bc0a-de84de8ec01a" providerId="ADAL" clId="{8BBF6A6C-3082-43EC-BD2E-60040FDC56BB}" dt="2022-08-01T18:20:17.128" v="160" actId="1076"/>
          <ac:spMkLst>
            <pc:docMk/>
            <pc:sldMk cId="3297094394" sldId="257"/>
            <ac:spMk id="14" creationId="{FE4720AF-D941-541B-FF0F-556C09A8C37B}"/>
          </ac:spMkLst>
        </pc:spChg>
        <pc:spChg chg="add mod">
          <ac:chgData name="Sabah Akhtar" userId="1c357625-e33f-447b-bc0a-de84de8ec01a" providerId="ADAL" clId="{8BBF6A6C-3082-43EC-BD2E-60040FDC56BB}" dt="2022-08-01T18:20:17.128" v="160" actId="1076"/>
          <ac:spMkLst>
            <pc:docMk/>
            <pc:sldMk cId="3297094394" sldId="257"/>
            <ac:spMk id="16" creationId="{F79B9710-9190-4E6F-8F2E-CA7616E4F655}"/>
          </ac:spMkLst>
        </pc:spChg>
        <pc:spChg chg="add mod">
          <ac:chgData name="Sabah Akhtar" userId="1c357625-e33f-447b-bc0a-de84de8ec01a" providerId="ADAL" clId="{8BBF6A6C-3082-43EC-BD2E-60040FDC56BB}" dt="2022-07-30T11:25:22.368" v="101" actId="20577"/>
          <ac:spMkLst>
            <pc:docMk/>
            <pc:sldMk cId="3297094394" sldId="257"/>
            <ac:spMk id="18" creationId="{AA668CA0-2BE4-99C8-420B-3975B1DFC0DB}"/>
          </ac:spMkLst>
        </pc:spChg>
        <pc:spChg chg="add mod">
          <ac:chgData name="Sabah Akhtar" userId="1c357625-e33f-447b-bc0a-de84de8ec01a" providerId="ADAL" clId="{8BBF6A6C-3082-43EC-BD2E-60040FDC56BB}" dt="2022-07-30T19:24:59.534" v="144" actId="947"/>
          <ac:spMkLst>
            <pc:docMk/>
            <pc:sldMk cId="3297094394" sldId="257"/>
            <ac:spMk id="19" creationId="{B1D156EE-55B2-1496-20CC-0F56F50D57B7}"/>
          </ac:spMkLst>
        </pc:spChg>
        <pc:spChg chg="add mod">
          <ac:chgData name="Sabah Akhtar" userId="1c357625-e33f-447b-bc0a-de84de8ec01a" providerId="ADAL" clId="{8BBF6A6C-3082-43EC-BD2E-60040FDC56BB}" dt="2022-08-01T18:20:54.510" v="300" actId="20577"/>
          <ac:spMkLst>
            <pc:docMk/>
            <pc:sldMk cId="3297094394" sldId="257"/>
            <ac:spMk id="20" creationId="{9A12C73B-65FF-0FD2-074B-7C0C4FC6890E}"/>
          </ac:spMkLst>
        </pc:spChg>
        <pc:spChg chg="add del mod">
          <ac:chgData name="Sabah Akhtar" userId="1c357625-e33f-447b-bc0a-de84de8ec01a" providerId="ADAL" clId="{8BBF6A6C-3082-43EC-BD2E-60040FDC56BB}" dt="2022-08-01T18:19:45.614" v="150" actId="478"/>
          <ac:spMkLst>
            <pc:docMk/>
            <pc:sldMk cId="3297094394" sldId="257"/>
            <ac:spMk id="21" creationId="{493C4C2F-3EDD-0021-0F3E-FCE7D14EB484}"/>
          </ac:spMkLst>
        </pc:spChg>
        <pc:spChg chg="add mod">
          <ac:chgData name="Sabah Akhtar" userId="1c357625-e33f-447b-bc0a-de84de8ec01a" providerId="ADAL" clId="{8BBF6A6C-3082-43EC-BD2E-60040FDC56BB}" dt="2022-08-01T18:21:17.461" v="425" actId="20577"/>
          <ac:spMkLst>
            <pc:docMk/>
            <pc:sldMk cId="3297094394" sldId="257"/>
            <ac:spMk id="22" creationId="{F6601B6A-41D1-29F4-F350-FA6B2D8C0A22}"/>
          </ac:spMkLst>
        </pc:spChg>
        <pc:picChg chg="add mod">
          <ac:chgData name="Sabah Akhtar" userId="1c357625-e33f-447b-bc0a-de84de8ec01a" providerId="ADAL" clId="{8BBF6A6C-3082-43EC-BD2E-60040FDC56BB}" dt="2022-07-27T14:40:43.577" v="89" actId="1076"/>
          <ac:picMkLst>
            <pc:docMk/>
            <pc:sldMk cId="3297094394" sldId="257"/>
            <ac:picMk id="3" creationId="{E01EAEF5-487F-59EB-38C8-3116E9B3F7DD}"/>
          </ac:picMkLst>
        </pc:picChg>
        <pc:picChg chg="add mod">
          <ac:chgData name="Sabah Akhtar" userId="1c357625-e33f-447b-bc0a-de84de8ec01a" providerId="ADAL" clId="{8BBF6A6C-3082-43EC-BD2E-60040FDC56BB}" dt="2022-07-27T14:40:43.577" v="89" actId="1076"/>
          <ac:picMkLst>
            <pc:docMk/>
            <pc:sldMk cId="3297094394" sldId="257"/>
            <ac:picMk id="5" creationId="{9358CA3F-48A5-49A0-9D37-876774671595}"/>
          </ac:picMkLst>
        </pc:picChg>
        <pc:picChg chg="add mod">
          <ac:chgData name="Sabah Akhtar" userId="1c357625-e33f-447b-bc0a-de84de8ec01a" providerId="ADAL" clId="{8BBF6A6C-3082-43EC-BD2E-60040FDC56BB}" dt="2022-07-27T14:40:43.577" v="89" actId="1076"/>
          <ac:picMkLst>
            <pc:docMk/>
            <pc:sldMk cId="3297094394" sldId="257"/>
            <ac:picMk id="7" creationId="{71CFBBDA-6545-248B-4997-89ABE1BC993C}"/>
          </ac:picMkLst>
        </pc:picChg>
        <pc:picChg chg="add mod">
          <ac:chgData name="Sabah Akhtar" userId="1c357625-e33f-447b-bc0a-de84de8ec01a" providerId="ADAL" clId="{8BBF6A6C-3082-43EC-BD2E-60040FDC56BB}" dt="2022-07-27T14:40:43.577" v="89" actId="1076"/>
          <ac:picMkLst>
            <pc:docMk/>
            <pc:sldMk cId="3297094394" sldId="257"/>
            <ac:picMk id="9" creationId="{04430B95-F705-E542-5C29-02173AAEC868}"/>
          </ac:picMkLst>
        </pc:picChg>
        <pc:picChg chg="add mod">
          <ac:chgData name="Sabah Akhtar" userId="1c357625-e33f-447b-bc0a-de84de8ec01a" providerId="ADAL" clId="{8BBF6A6C-3082-43EC-BD2E-60040FDC56BB}" dt="2022-08-01T18:20:17.128" v="160" actId="1076"/>
          <ac:picMkLst>
            <pc:docMk/>
            <pc:sldMk cId="3297094394" sldId="257"/>
            <ac:picMk id="11" creationId="{C226874A-A49B-8C19-0659-84AC0B1479E5}"/>
          </ac:picMkLst>
        </pc:picChg>
        <pc:picChg chg="add mod">
          <ac:chgData name="Sabah Akhtar" userId="1c357625-e33f-447b-bc0a-de84de8ec01a" providerId="ADAL" clId="{8BBF6A6C-3082-43EC-BD2E-60040FDC56BB}" dt="2022-08-01T18:20:17.128" v="160" actId="1076"/>
          <ac:picMkLst>
            <pc:docMk/>
            <pc:sldMk cId="3297094394" sldId="257"/>
            <ac:picMk id="13" creationId="{13D3A14D-3603-E9BE-D981-EB545E8D170F}"/>
          </ac:picMkLst>
        </pc:picChg>
        <pc:picChg chg="add mod">
          <ac:chgData name="Sabah Akhtar" userId="1c357625-e33f-447b-bc0a-de84de8ec01a" providerId="ADAL" clId="{8BBF6A6C-3082-43EC-BD2E-60040FDC56BB}" dt="2022-08-01T18:20:17.128" v="160" actId="1076"/>
          <ac:picMkLst>
            <pc:docMk/>
            <pc:sldMk cId="3297094394" sldId="257"/>
            <ac:picMk id="15" creationId="{27CAD7E9-691D-686D-D9A6-4A28E4812F40}"/>
          </ac:picMkLst>
        </pc:picChg>
        <pc:picChg chg="add mod">
          <ac:chgData name="Sabah Akhtar" userId="1c357625-e33f-447b-bc0a-de84de8ec01a" providerId="ADAL" clId="{8BBF6A6C-3082-43EC-BD2E-60040FDC56BB}" dt="2022-08-01T18:20:17.128" v="160" actId="1076"/>
          <ac:picMkLst>
            <pc:docMk/>
            <pc:sldMk cId="3297094394" sldId="257"/>
            <ac:picMk id="17" creationId="{F007118D-8DE1-1F4F-F811-070A05EFCB29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FE2ADB-F64A-CD27-2CB0-331A40A264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C832EF-D66E-98F8-D473-C16CBE9BA8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C198DD-9C5E-908F-05F9-FE31446A1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7F14B-9AE8-46E3-A4D6-CEF40294E355}" type="datetimeFigureOut">
              <a:rPr lang="en-GB" smtClean="0"/>
              <a:t>1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994434-3436-9531-1283-685440440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295FFB-6BFE-ED52-227F-2EC145029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36E7A-0E90-4BF8-936E-EF2AC4AF3F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08251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1BF8AD-1C9A-82A3-E986-DA5B90D8F8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7004F4B-2873-555C-4129-8A0714E458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09A11B-FC43-943F-27A0-A2A0983D7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7F14B-9AE8-46E3-A4D6-CEF40294E355}" type="datetimeFigureOut">
              <a:rPr lang="en-GB" smtClean="0"/>
              <a:t>1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BAB65-096A-901D-92A4-8950CE3942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AE8C96-8070-AA93-6192-E12C3EA952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36E7A-0E90-4BF8-936E-EF2AC4AF3F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9875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0B4F49-15F6-D423-A2C3-36944CBD43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AFB852-DEEA-6C8F-70DF-20BCDE98CB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859148-E300-3697-AD33-BD55C869A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7F14B-9AE8-46E3-A4D6-CEF40294E355}" type="datetimeFigureOut">
              <a:rPr lang="en-GB" smtClean="0"/>
              <a:t>1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6DE9EE-4D00-0945-5D2E-212E8207F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C8BBFC-5329-E706-D0B5-A85CCCA58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36E7A-0E90-4BF8-936E-EF2AC4AF3F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4961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650AF1-FE75-929B-8483-B4532843A6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53D08D-D2FF-E5F1-3B97-73C94C0A40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18CE03-FBED-5815-0246-BDD03AD2B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7F14B-9AE8-46E3-A4D6-CEF40294E355}" type="datetimeFigureOut">
              <a:rPr lang="en-GB" smtClean="0"/>
              <a:t>1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8A3BBD-E211-A292-3A62-0EFA9948D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082159-47BE-C809-6090-CF8B8BAFF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36E7A-0E90-4BF8-936E-EF2AC4AF3F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0479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42CADA-0269-3E46-8776-A113FE1A9B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730CD3-4976-E0A4-EF40-5B21139F2F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A903B4-82FD-70CC-76C4-CC10AEF58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7F14B-9AE8-46E3-A4D6-CEF40294E355}" type="datetimeFigureOut">
              <a:rPr lang="en-GB" smtClean="0"/>
              <a:t>1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B59E33-2AD1-D31C-22F2-7C33E1A7D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1DF26A-4B2F-AFBB-BC3D-7E0B69A167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36E7A-0E90-4BF8-936E-EF2AC4AF3F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1512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CB7944-B9E9-F3F1-161A-F84743D53A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69532B-51B2-55FD-8403-DB511B877A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5DACE5-98A6-3BA6-9A70-CD0535D684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723171-FCFA-A593-D096-2743DE4C3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7F14B-9AE8-46E3-A4D6-CEF40294E355}" type="datetimeFigureOut">
              <a:rPr lang="en-GB" smtClean="0"/>
              <a:t>18/1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6897A1-6EA4-B77F-267B-846A1C077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4C1D93-F418-8F18-DD80-927285129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36E7A-0E90-4BF8-936E-EF2AC4AF3F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1620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BB59C6-601A-8FFB-9D08-19DC0C4207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2E6EA7-9604-F357-9467-23CE451D8D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E815B4-6C7A-D1EC-C7CE-D3B15C436B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5110930-3A06-8C1E-5546-E2117E5436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AD74AB-D276-11FD-704C-4012C6CFBB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47F4FCC-09F0-DE3B-F8AF-2309A1D25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7F14B-9AE8-46E3-A4D6-CEF40294E355}" type="datetimeFigureOut">
              <a:rPr lang="en-GB" smtClean="0"/>
              <a:t>18/11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BD63CE2-B934-9DB9-EAA7-C600D45E2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210D65F-7556-4935-DAA1-D91A9662C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36E7A-0E90-4BF8-936E-EF2AC4AF3F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4900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8D68D7-2D9B-2635-44F8-7C2E072C19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5602314-94FB-E7C5-A804-74A42BF3F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7F14B-9AE8-46E3-A4D6-CEF40294E355}" type="datetimeFigureOut">
              <a:rPr lang="en-GB" smtClean="0"/>
              <a:t>18/11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3F5310-9814-55C3-9F34-BDD369B428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C57E336-72CA-96FB-1987-7D143FD18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36E7A-0E90-4BF8-936E-EF2AC4AF3F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6412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7D6263-9712-BC87-0CF2-2385605C1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7F14B-9AE8-46E3-A4D6-CEF40294E355}" type="datetimeFigureOut">
              <a:rPr lang="en-GB" smtClean="0"/>
              <a:t>18/11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68CC77-9472-BAF8-C779-AF4C33A09C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1DDF946-1DB2-C180-2CFE-FE61CE4DD5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36E7A-0E90-4BF8-936E-EF2AC4AF3F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0774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3FD8E-1EE6-D62C-0EAE-82791C0D08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A68170-41FC-33CB-A242-DEECA59A84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FE521A-DCC4-3024-EB8D-2E4941D376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5DDEB6-4C80-A1DD-E53B-16547366C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7F14B-9AE8-46E3-A4D6-CEF40294E355}" type="datetimeFigureOut">
              <a:rPr lang="en-GB" smtClean="0"/>
              <a:t>18/1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B38653-3BB1-2DA6-B232-064697F5B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C3259D-3BEF-7E2F-6952-DD3F41F04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36E7A-0E90-4BF8-936E-EF2AC4AF3F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857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82326C-1CCF-4F66-61A2-31A009320C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360A549-1B9D-54C4-332E-2E0A411FDB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873AF2-6213-850D-ECCD-193D688563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B19083-1492-A172-344E-D9B61C0D9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7F14B-9AE8-46E3-A4D6-CEF40294E355}" type="datetimeFigureOut">
              <a:rPr lang="en-GB" smtClean="0"/>
              <a:t>18/1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22385B-20A9-81A0-45F7-CE4C428DB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A3BBD7-8CE4-CB0B-28A6-98F6E8A648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36E7A-0E90-4BF8-936E-EF2AC4AF3F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9973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D714F5A-9474-CB2B-2927-0731E80390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D923BC-37A7-4BBF-80DF-8B76A36826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36376B-840F-805E-4675-371A537EFF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7F14B-9AE8-46E3-A4D6-CEF40294E355}" type="datetimeFigureOut">
              <a:rPr lang="en-GB" smtClean="0"/>
              <a:t>1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B500DD-973A-AD13-87C5-7F1959E191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1B3853-E956-EEDD-3A12-D703201406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F36E7A-0E90-4BF8-936E-EF2AC4AF3F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3581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854B11C-CE5F-905A-1154-EE7ED62C4317}"/>
              </a:ext>
            </a:extLst>
          </p:cNvPr>
          <p:cNvSpPr txBox="1"/>
          <p:nvPr/>
        </p:nvSpPr>
        <p:spPr>
          <a:xfrm flipH="1">
            <a:off x="1045564" y="715618"/>
            <a:ext cx="16392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/>
              <a:t>U266-48h</a:t>
            </a:r>
          </a:p>
        </p:txBody>
      </p:sp>
      <p:pic>
        <p:nvPicPr>
          <p:cNvPr id="3" name="Picture 2" descr="Shape, rectangle&#10;&#10;Description automatically generated">
            <a:extLst>
              <a:ext uri="{FF2B5EF4-FFF2-40B4-BE49-F238E27FC236}">
                <a16:creationId xmlns:a16="http://schemas.microsoft.com/office/drawing/2014/main" id="{E01EAEF5-487F-59EB-38C8-3116E9B3F7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925" y="1137389"/>
            <a:ext cx="2678126" cy="173496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8AB5389-FF08-0181-A8C5-B1788ED22682}"/>
              </a:ext>
            </a:extLst>
          </p:cNvPr>
          <p:cNvSpPr txBox="1"/>
          <p:nvPr/>
        </p:nvSpPr>
        <p:spPr>
          <a:xfrm flipH="1">
            <a:off x="4084187" y="716890"/>
            <a:ext cx="1379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/>
              <a:t>U266-72h</a:t>
            </a:r>
          </a:p>
        </p:txBody>
      </p:sp>
      <p:pic>
        <p:nvPicPr>
          <p:cNvPr id="5" name="Picture 4" descr="Shape&#10;&#10;Description automatically generated">
            <a:extLst>
              <a:ext uri="{FF2B5EF4-FFF2-40B4-BE49-F238E27FC236}">
                <a16:creationId xmlns:a16="http://schemas.microsoft.com/office/drawing/2014/main" id="{9358CA3F-48A5-49A0-9D37-87677467159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6059" y="1137212"/>
            <a:ext cx="2678400" cy="17351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45F4BAE-A7F9-2153-7047-9C8C6A6BFACA}"/>
              </a:ext>
            </a:extLst>
          </p:cNvPr>
          <p:cNvSpPr txBox="1"/>
          <p:nvPr/>
        </p:nvSpPr>
        <p:spPr>
          <a:xfrm flipH="1">
            <a:off x="6810052" y="762549"/>
            <a:ext cx="13259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/>
              <a:t>U266-96h</a:t>
            </a:r>
          </a:p>
        </p:txBody>
      </p:sp>
      <p:pic>
        <p:nvPicPr>
          <p:cNvPr id="7" name="Picture 6" descr="Shape&#10;&#10;Description automatically generated with medium confidence">
            <a:extLst>
              <a:ext uri="{FF2B5EF4-FFF2-40B4-BE49-F238E27FC236}">
                <a16:creationId xmlns:a16="http://schemas.microsoft.com/office/drawing/2014/main" id="{71CFBBDA-6545-248B-4997-89ABE1BC993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6432" y="1156679"/>
            <a:ext cx="2678400" cy="173513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882B9C8-266A-31FC-2F48-451773857267}"/>
              </a:ext>
            </a:extLst>
          </p:cNvPr>
          <p:cNvSpPr txBox="1"/>
          <p:nvPr/>
        </p:nvSpPr>
        <p:spPr>
          <a:xfrm flipH="1">
            <a:off x="8977745" y="758190"/>
            <a:ext cx="2563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/>
              <a:t>RPMI 8226-48h</a:t>
            </a:r>
          </a:p>
        </p:txBody>
      </p:sp>
      <p:pic>
        <p:nvPicPr>
          <p:cNvPr id="9" name="Picture 8" descr="Shape, rectangle&#10;&#10;Description automatically generated">
            <a:extLst>
              <a:ext uri="{FF2B5EF4-FFF2-40B4-BE49-F238E27FC236}">
                <a16:creationId xmlns:a16="http://schemas.microsoft.com/office/drawing/2014/main" id="{04430B95-F705-E542-5C29-02173AAEC86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3091" y="1137212"/>
            <a:ext cx="2678400" cy="173513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6F10B90-7102-0981-550D-C44EE518D0B6}"/>
              </a:ext>
            </a:extLst>
          </p:cNvPr>
          <p:cNvSpPr txBox="1"/>
          <p:nvPr/>
        </p:nvSpPr>
        <p:spPr>
          <a:xfrm flipH="1">
            <a:off x="604057" y="3413957"/>
            <a:ext cx="22882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/>
              <a:t>RPMI 8226-72h</a:t>
            </a:r>
          </a:p>
        </p:txBody>
      </p:sp>
      <p:pic>
        <p:nvPicPr>
          <p:cNvPr id="11" name="Picture 10" descr="A picture containing shape&#10;&#10;Description automatically generated">
            <a:extLst>
              <a:ext uri="{FF2B5EF4-FFF2-40B4-BE49-F238E27FC236}">
                <a16:creationId xmlns:a16="http://schemas.microsoft.com/office/drawing/2014/main" id="{C226874A-A49B-8C19-0659-84AC0B1479E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926" y="3814067"/>
            <a:ext cx="2678128" cy="173496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9EC8B84-287F-F410-7FDA-33F4D29AEED8}"/>
              </a:ext>
            </a:extLst>
          </p:cNvPr>
          <p:cNvSpPr txBox="1"/>
          <p:nvPr/>
        </p:nvSpPr>
        <p:spPr>
          <a:xfrm flipH="1">
            <a:off x="3492590" y="3413957"/>
            <a:ext cx="26281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/>
              <a:t>RPMI 8226-96h</a:t>
            </a:r>
          </a:p>
        </p:txBody>
      </p:sp>
      <p:pic>
        <p:nvPicPr>
          <p:cNvPr id="13" name="Picture 12" descr="Shape&#10;&#10;Description automatically generated">
            <a:extLst>
              <a:ext uri="{FF2B5EF4-FFF2-40B4-BE49-F238E27FC236}">
                <a16:creationId xmlns:a16="http://schemas.microsoft.com/office/drawing/2014/main" id="{13D3A14D-3603-E9BE-D981-EB545E8D170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2918" y="3814067"/>
            <a:ext cx="2678400" cy="17351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E4720AF-D941-541B-FF0F-556C09A8C37B}"/>
              </a:ext>
            </a:extLst>
          </p:cNvPr>
          <p:cNvSpPr txBox="1"/>
          <p:nvPr/>
        </p:nvSpPr>
        <p:spPr>
          <a:xfrm flipH="1">
            <a:off x="6656736" y="3413957"/>
            <a:ext cx="16703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/>
              <a:t>MM.1S-72h</a:t>
            </a:r>
          </a:p>
        </p:txBody>
      </p:sp>
      <p:pic>
        <p:nvPicPr>
          <p:cNvPr id="15" name="Picture 14" descr="Shape&#10;&#10;Description automatically generated">
            <a:extLst>
              <a:ext uri="{FF2B5EF4-FFF2-40B4-BE49-F238E27FC236}">
                <a16:creationId xmlns:a16="http://schemas.microsoft.com/office/drawing/2014/main" id="{27CAD7E9-691D-686D-D9A6-4A28E4812F4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6432" y="3814067"/>
            <a:ext cx="2678400" cy="17351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F79B9710-9190-4E6F-8F2E-CA7616E4F655}"/>
              </a:ext>
            </a:extLst>
          </p:cNvPr>
          <p:cNvSpPr txBox="1"/>
          <p:nvPr/>
        </p:nvSpPr>
        <p:spPr>
          <a:xfrm flipH="1">
            <a:off x="9694064" y="3413957"/>
            <a:ext cx="14667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/>
              <a:t>MM.1S-96h</a:t>
            </a:r>
          </a:p>
        </p:txBody>
      </p:sp>
      <p:pic>
        <p:nvPicPr>
          <p:cNvPr id="17" name="Picture 16" descr="Shape&#10;&#10;Description automatically generated">
            <a:extLst>
              <a:ext uri="{FF2B5EF4-FFF2-40B4-BE49-F238E27FC236}">
                <a16:creationId xmlns:a16="http://schemas.microsoft.com/office/drawing/2014/main" id="{F007118D-8DE1-1F4F-F811-070A05EFCB2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3091" y="3814067"/>
            <a:ext cx="2678400" cy="173513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AA668CA0-2BE4-99C8-420B-3975B1DFC0DB}"/>
              </a:ext>
            </a:extLst>
          </p:cNvPr>
          <p:cNvSpPr txBox="1"/>
          <p:nvPr/>
        </p:nvSpPr>
        <p:spPr>
          <a:xfrm>
            <a:off x="9686394" y="83807"/>
            <a:ext cx="25795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2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A12C73B-65FF-0FD2-074B-7C0C4FC6890E}"/>
              </a:ext>
            </a:extLst>
          </p:cNvPr>
          <p:cNvSpPr txBox="1"/>
          <p:nvPr/>
        </p:nvSpPr>
        <p:spPr>
          <a:xfrm>
            <a:off x="306217" y="395726"/>
            <a:ext cx="96136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B                                         C                                          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6601B6A-41D1-29F4-F350-FA6B2D8C0A22}"/>
              </a:ext>
            </a:extLst>
          </p:cNvPr>
          <p:cNvSpPr txBox="1"/>
          <p:nvPr/>
        </p:nvSpPr>
        <p:spPr>
          <a:xfrm>
            <a:off x="306217" y="3087793"/>
            <a:ext cx="9387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E                                          F                                          G                                         H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99026B2-60E3-40CB-8D7C-339D82284A3E}"/>
              </a:ext>
            </a:extLst>
          </p:cNvPr>
          <p:cNvSpPr/>
          <p:nvPr/>
        </p:nvSpPr>
        <p:spPr>
          <a:xfrm>
            <a:off x="488924" y="5779860"/>
            <a:ext cx="10984807" cy="7911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</a:t>
            </a:r>
            <a:r>
              <a:rPr lang="en-US" sz="1600" b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2</a:t>
            </a:r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IC50 values were calculated after treatment with 5, 10, 25, and 50 µM GS for (</a:t>
            </a:r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, B </a:t>
            </a:r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</a:t>
            </a:r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</a:t>
            </a:r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U266, (</a:t>
            </a:r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, E </a:t>
            </a:r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</a:t>
            </a:r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F</a:t>
            </a:r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PMI 8226</a:t>
            </a:r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 (</a:t>
            </a:r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 </a:t>
            </a:r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</a:t>
            </a:r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</a:t>
            </a:r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MM.1S cells. </a:t>
            </a:r>
            <a:endParaRPr lang="en-US" sz="1600" dirty="0"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7094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85</TotalTime>
  <Words>77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bah Akhtar</dc:creator>
  <cp:lastModifiedBy>MDPI</cp:lastModifiedBy>
  <cp:revision>5</cp:revision>
  <dcterms:created xsi:type="dcterms:W3CDTF">2022-07-27T14:30:43Z</dcterms:created>
  <dcterms:modified xsi:type="dcterms:W3CDTF">2022-11-18T07:08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73f5887-035d-4765-8d10-97aaac8deb4a_Enabled">
    <vt:lpwstr>true</vt:lpwstr>
  </property>
  <property fmtid="{D5CDD505-2E9C-101B-9397-08002B2CF9AE}" pid="3" name="MSIP_Label_573f5887-035d-4765-8d10-97aaac8deb4a_SetDate">
    <vt:lpwstr>2022-10-03T12:12:25Z</vt:lpwstr>
  </property>
  <property fmtid="{D5CDD505-2E9C-101B-9397-08002B2CF9AE}" pid="4" name="MSIP_Label_573f5887-035d-4765-8d10-97aaac8deb4a_Method">
    <vt:lpwstr>Standard</vt:lpwstr>
  </property>
  <property fmtid="{D5CDD505-2E9C-101B-9397-08002B2CF9AE}" pid="5" name="MSIP_Label_573f5887-035d-4765-8d10-97aaac8deb4a_Name">
    <vt:lpwstr>Public</vt:lpwstr>
  </property>
  <property fmtid="{D5CDD505-2E9C-101B-9397-08002B2CF9AE}" pid="6" name="MSIP_Label_573f5887-035d-4765-8d10-97aaac8deb4a_SiteId">
    <vt:lpwstr>f08ae827-76a0-4eda-8325-df208f3835ab</vt:lpwstr>
  </property>
  <property fmtid="{D5CDD505-2E9C-101B-9397-08002B2CF9AE}" pid="7" name="MSIP_Label_573f5887-035d-4765-8d10-97aaac8deb4a_ActionId">
    <vt:lpwstr>b7610489-6a2d-4f31-978e-a80be480a5bb</vt:lpwstr>
  </property>
  <property fmtid="{D5CDD505-2E9C-101B-9397-08002B2CF9AE}" pid="8" name="MSIP_Label_573f5887-035d-4765-8d10-97aaac8deb4a_ContentBits">
    <vt:lpwstr>0</vt:lpwstr>
  </property>
</Properties>
</file>